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792913" cy="990758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EFA521-C8AA-4AF7-87A2-A83F76DEE61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DD16AF-A699-4B3E-AFC9-26B58966404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17F2BB-08D2-4617-8B26-B679A09C59E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337D65-80D8-4F53-9E2F-0391CA608B3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30289F-BD6B-4C1E-9C16-FE8DFE911CB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46321D-3D1C-4ECC-888E-F1AD794D2DF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1EEE8D-2C38-4F29-9910-8544719456F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BC3AA5-90C9-4DB5-90C8-01229C39122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6B6D3B-C29D-4E72-89AC-937D8403C81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9FC6B8-0383-4C12-ADD9-D2B705DF697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10A484-1BFD-481D-B065-4A4911BDF09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00F6F1-A4D2-43E8-AAD0-234E5F50B23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9432033-5BF8-462D-A93A-D4AA2860DEC4}" type="datetime">
              <a:rPr b="0" lang="en-US" sz="1200" spc="-1" strike="noStrike">
                <a:solidFill>
                  <a:srgbClr val="898989"/>
                </a:solidFill>
                <a:latin typeface="Arial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9746C9D-7BD3-4BAA-8C84-989A5D0673DE}" type="slidenum">
              <a:rPr b="0" lang="en-US" sz="1200" spc="-1" strike="noStrike">
                <a:solidFill>
                  <a:srgbClr val="898989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498600" y="1484280"/>
          <a:ext cx="8064360" cy="1857240"/>
        </p:xfrm>
        <a:graphic>
          <a:graphicData uri="http://schemas.openxmlformats.org/drawingml/2006/table">
            <a:tbl>
              <a:tblPr/>
              <a:tblGrid>
                <a:gridCol w="3095640"/>
                <a:gridCol w="993600"/>
                <a:gridCol w="993960"/>
                <a:gridCol w="993600"/>
                <a:gridCol w="993960"/>
                <a:gridCol w="993600"/>
              </a:tblGrid>
              <a:tr h="309600">
                <a:tc>
                  <a:txBody>
                    <a:bodyPr lIns="68400" rIns="68400" tIns="0" bIns="0" anchor="ctr">
                      <a:noAutofit/>
                    </a:bodyPr>
                    <a:p>
                      <a:pPr algn="just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TV1.C gp12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Run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Run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Run3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TB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TB5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</a:tr>
              <a:tr h="309600">
                <a:tc>
                  <a:txBody>
                    <a:bodyPr lIns="68400" rIns="68400" tIns="0" bIns="0" anchor="ctr">
                      <a:noAutofit/>
                    </a:bodyPr>
                    <a:p>
                      <a:pPr algn="just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otal gp120 mg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.7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.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.3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.8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</a:tr>
              <a:tr h="309600">
                <a:tc>
                  <a:txBody>
                    <a:bodyPr lIns="68400" rIns="68400" tIns="0" bIns="0" anchor="ctr">
                      <a:noAutofit/>
                    </a:bodyPr>
                    <a:p>
                      <a:pPr algn="just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urity (RP-HPLC/SEC-HPLC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309600">
                <a:tc>
                  <a:txBody>
                    <a:bodyPr lIns="68400" rIns="68400" tIns="0" bIns="0" anchor="ctr">
                      <a:noAutofit/>
                    </a:bodyPr>
                    <a:p>
                      <a:pPr algn="just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onomer gp120 %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7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5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</a:tr>
              <a:tr h="309600">
                <a:tc>
                  <a:txBody>
                    <a:bodyPr lIns="68400" rIns="68400" tIns="0" bIns="0" anchor="ctr">
                      <a:noAutofit/>
                    </a:bodyPr>
                    <a:p>
                      <a:pPr algn="just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otal gp120 yield %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9.3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8.5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9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3.7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9.3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309240">
                <a:tc>
                  <a:txBody>
                    <a:bodyPr lIns="68400" rIns="68400" tIns="0" bIns="0" anchor="ctr">
                      <a:noAutofit/>
                    </a:bodyPr>
                    <a:p>
                      <a:pPr algn="just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onomer gp120 yield %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1.8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8.8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3.9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5.9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9.3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42" name=""/>
          <p:cNvGraphicFramePr/>
          <p:nvPr/>
        </p:nvGraphicFramePr>
        <p:xfrm>
          <a:off x="498600" y="3552840"/>
          <a:ext cx="8064360" cy="1857240"/>
        </p:xfrm>
        <a:graphic>
          <a:graphicData uri="http://schemas.openxmlformats.org/drawingml/2006/table">
            <a:tbl>
              <a:tblPr/>
              <a:tblGrid>
                <a:gridCol w="3095640"/>
                <a:gridCol w="993600"/>
                <a:gridCol w="993960"/>
                <a:gridCol w="993600"/>
                <a:gridCol w="993960"/>
                <a:gridCol w="993600"/>
              </a:tblGrid>
              <a:tr h="309600">
                <a:tc>
                  <a:txBody>
                    <a:bodyPr lIns="68400" rIns="68400" tIns="0" bIns="0" anchor="ctr">
                      <a:noAutofit/>
                    </a:bodyPr>
                    <a:p>
                      <a:pPr algn="just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1086.C gp12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Run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Run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Run3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TB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TB5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</a:tr>
              <a:tr h="309600">
                <a:tc>
                  <a:txBody>
                    <a:bodyPr lIns="68400" rIns="68400" tIns="0" bIns="0" anchor="ctr">
                      <a:noAutofit/>
                    </a:bodyPr>
                    <a:p>
                      <a:pPr algn="just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otal gp120 mg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5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3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7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</a:tr>
              <a:tr h="309600">
                <a:tc>
                  <a:txBody>
                    <a:bodyPr lIns="68400" rIns="68400" tIns="0" bIns="0" anchor="ctr">
                      <a:noAutofit/>
                    </a:bodyPr>
                    <a:p>
                      <a:pPr algn="just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urity (RP-HPLC/SEC-HPLC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0.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0.3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7.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309600">
                <a:tc>
                  <a:txBody>
                    <a:bodyPr lIns="68400" rIns="68400" tIns="0" bIns="0" anchor="ctr">
                      <a:noAutofit/>
                    </a:bodyPr>
                    <a:p>
                      <a:pPr algn="just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onomer gp120 %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7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7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7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8.5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</a:tr>
              <a:tr h="309240">
                <a:tc>
                  <a:txBody>
                    <a:bodyPr lIns="68400" rIns="68400" tIns="0" bIns="0" anchor="ctr">
                      <a:noAutofit/>
                    </a:bodyPr>
                    <a:p>
                      <a:pPr algn="just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otal gp120 yield %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5.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8.8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0.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d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d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309600">
                <a:tc>
                  <a:txBody>
                    <a:bodyPr lIns="68400" rIns="68400" tIns="0" bIns="0" anchor="ctr">
                      <a:noAutofit/>
                    </a:bodyPr>
                    <a:p>
                      <a:pPr algn="just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onomer gp120 yield %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</a:tr>
            </a:tbl>
          </a:graphicData>
        </a:graphic>
      </p:graphicFrame>
      <p:sp>
        <p:nvSpPr>
          <p:cNvPr id="43" name="TextBox 1"/>
          <p:cNvSpPr/>
          <p:nvPr/>
        </p:nvSpPr>
        <p:spPr>
          <a:xfrm>
            <a:off x="152280" y="103320"/>
            <a:ext cx="8534520" cy="429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Arial"/>
              </a:rPr>
              <a:t>Supplementary Table S8 </a:t>
            </a: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Box 3"/>
          <p:cNvSpPr/>
          <p:nvPr/>
        </p:nvSpPr>
        <p:spPr>
          <a:xfrm>
            <a:off x="619200" y="5410080"/>
            <a:ext cx="50544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Arial"/>
              </a:rPr>
              <a:t>N/A, value not reported due to the consistently low level of dimer prote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Arial"/>
              </a:rPr>
              <a:t>Nd, not determin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263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10-02T14:58:51Z</dcterms:created>
  <dc:creator>deyan3</dc:creator>
  <dc:description/>
  <dc:language>en-US</dc:language>
  <cp:lastModifiedBy>Carlo</cp:lastModifiedBy>
  <cp:lastPrinted>2015-01-02T11:46:15Z</cp:lastPrinted>
  <dcterms:modified xsi:type="dcterms:W3CDTF">2016-04-18T21:57:34Z</dcterms:modified>
  <cp:revision>183</cp:revision>
  <dc:subject/>
  <dc:title>Slide 1</dc:title>
</cp:coreProperties>
</file>